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1" r:id="rId2"/>
    <p:sldId id="262" r:id="rId3"/>
    <p:sldId id="264" r:id="rId4"/>
  </p:sldIdLst>
  <p:sldSz cx="25923875" cy="34564638"/>
  <p:notesSz cx="6797675" cy="9926638"/>
  <p:defaultTextStyle>
    <a:defPPr>
      <a:defRPr lang="de-DE"/>
    </a:defPPr>
    <a:lvl1pPr marL="0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1pPr>
    <a:lvl2pPr marL="1728216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2pPr>
    <a:lvl3pPr marL="3456432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3pPr>
    <a:lvl4pPr marL="5184648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4pPr>
    <a:lvl5pPr marL="6912864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5pPr>
    <a:lvl6pPr marL="8641080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6pPr>
    <a:lvl7pPr marL="10369296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7pPr>
    <a:lvl8pPr marL="12097512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8pPr>
    <a:lvl9pPr marL="13825728" algn="l" defTabSz="1728216" rtl="0" eaLnBrk="1" latinLnBrk="0" hangingPunct="1">
      <a:defRPr sz="6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439" userDrawn="1">
          <p15:clr>
            <a:srgbClr val="A4A3A4"/>
          </p15:clr>
        </p15:guide>
        <p15:guide id="3" orient="horz" pos="20412" userDrawn="1">
          <p15:clr>
            <a:srgbClr val="A4A3A4"/>
          </p15:clr>
        </p15:guide>
        <p15:guide id="4" pos="9242" userDrawn="1">
          <p15:clr>
            <a:srgbClr val="A4A3A4"/>
          </p15:clr>
        </p15:guide>
        <p15:guide id="5" orient="horz" pos="8922" userDrawn="1">
          <p15:clr>
            <a:srgbClr val="A4A3A4"/>
          </p15:clr>
        </p15:guide>
        <p15:guide id="6" orient="horz" pos="8035" userDrawn="1">
          <p15:clr>
            <a:srgbClr val="A4A3A4"/>
          </p15:clr>
        </p15:guide>
        <p15:guide id="7" orient="horz" pos="171">
          <p15:clr>
            <a:srgbClr val="A4A3A4"/>
          </p15:clr>
        </p15:guide>
        <p15:guide id="8" orient="horz" pos="10667">
          <p15:clr>
            <a:srgbClr val="A4A3A4"/>
          </p15:clr>
        </p15:guide>
        <p15:guide id="9" orient="horz" pos="18331">
          <p15:clr>
            <a:srgbClr val="A4A3A4"/>
          </p15:clr>
        </p15:guide>
        <p15:guide id="10" orient="horz" pos="20783">
          <p15:clr>
            <a:srgbClr val="A4A3A4"/>
          </p15:clr>
        </p15:guide>
        <p15:guide id="11" orient="horz" pos="10823" userDrawn="1">
          <p15:clr>
            <a:srgbClr val="A4A3A4"/>
          </p15:clr>
        </p15:guide>
        <p15:guide id="12" orient="horz" pos="8352" userDrawn="1">
          <p15:clr>
            <a:srgbClr val="A4A3A4"/>
          </p15:clr>
        </p15:guide>
        <p15:guide id="13" orient="horz" pos="2352">
          <p15:clr>
            <a:srgbClr val="A4A3A4"/>
          </p15:clr>
        </p15:guide>
        <p15:guide id="14" pos="485">
          <p15:clr>
            <a:srgbClr val="A4A3A4"/>
          </p15:clr>
        </p15:guide>
        <p15:guide id="16" orient="horz" pos="8732" userDrawn="1">
          <p15:clr>
            <a:srgbClr val="A4A3A4"/>
          </p15:clr>
        </p15:guide>
        <p15:guide id="17" orient="horz" pos="21025">
          <p15:clr>
            <a:srgbClr val="A4A3A4"/>
          </p15:clr>
        </p15:guide>
        <p15:guide id="18" pos="500">
          <p15:clr>
            <a:srgbClr val="A4A3A4"/>
          </p15:clr>
        </p15:guide>
        <p15:guide id="19" orient="horz" pos="21354">
          <p15:clr>
            <a:srgbClr val="A4A3A4"/>
          </p15:clr>
        </p15:guide>
        <p15:guide id="20" orient="horz" pos="15765" userDrawn="1">
          <p15:clr>
            <a:srgbClr val="A4A3A4"/>
          </p15:clr>
        </p15:guide>
        <p15:guide id="21" orient="horz" pos="8289" userDrawn="1">
          <p15:clr>
            <a:srgbClr val="A4A3A4"/>
          </p15:clr>
        </p15:guide>
        <p15:guide id="22" orient="horz" pos="17223" userDrawn="1">
          <p15:clr>
            <a:srgbClr val="A4A3A4"/>
          </p15:clr>
        </p15:guide>
        <p15:guide id="23" orient="horz" pos="13231" userDrawn="1">
          <p15:clr>
            <a:srgbClr val="A4A3A4"/>
          </p15:clr>
        </p15:guide>
        <p15:guide id="24" orient="horz" pos="4170" userDrawn="1">
          <p15:clr>
            <a:srgbClr val="A4A3A4"/>
          </p15:clr>
        </p15:guide>
        <p15:guide id="25" orient="horz" pos="3612">
          <p15:clr>
            <a:srgbClr val="A4A3A4"/>
          </p15:clr>
        </p15:guide>
        <p15:guide id="26" orient="horz" pos="2143" userDrawn="1">
          <p15:clr>
            <a:srgbClr val="A4A3A4"/>
          </p15:clr>
        </p15:guide>
        <p15:guide id="27" orient="horz" pos="7909" userDrawn="1">
          <p15:clr>
            <a:srgbClr val="A4A3A4"/>
          </p15:clr>
        </p15:guide>
        <p15:guide id="28" pos="15705" userDrawn="1">
          <p15:clr>
            <a:srgbClr val="A4A3A4"/>
          </p15:clr>
        </p15:guide>
        <p15:guide id="29" pos="8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  <a:srgbClr val="66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5595" autoAdjust="0"/>
  </p:normalViewPr>
  <p:slideViewPr>
    <p:cSldViewPr snapToObjects="1" showGuides="1">
      <p:cViewPr>
        <p:scale>
          <a:sx n="50" d="100"/>
          <a:sy n="50" d="100"/>
        </p:scale>
        <p:origin x="-168" y="-144"/>
      </p:cViewPr>
      <p:guideLst>
        <p:guide orient="horz" pos="18439"/>
        <p:guide orient="horz" pos="20412"/>
        <p:guide pos="9242"/>
        <p:guide orient="horz" pos="8922"/>
        <p:guide orient="horz" pos="8035"/>
        <p:guide orient="horz" pos="171"/>
        <p:guide orient="horz" pos="10667"/>
        <p:guide orient="horz" pos="18331"/>
        <p:guide orient="horz" pos="20783"/>
        <p:guide orient="horz" pos="10823"/>
        <p:guide orient="horz" pos="8352"/>
        <p:guide orient="horz" pos="2352"/>
        <p:guide pos="485"/>
        <p:guide orient="horz" pos="8732"/>
        <p:guide orient="horz" pos="21025"/>
        <p:guide pos="500"/>
        <p:guide orient="horz" pos="21354"/>
        <p:guide orient="horz" pos="15765"/>
        <p:guide orient="horz" pos="8289"/>
        <p:guide orient="horz" pos="17223"/>
        <p:guide orient="horz" pos="13231"/>
        <p:guide orient="horz" pos="4170"/>
        <p:guide orient="horz" pos="3612"/>
        <p:guide orient="horz" pos="2143"/>
        <p:guide orient="horz" pos="7909"/>
        <p:guide pos="15705"/>
        <p:guide pos="816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100585" cy="10058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066D50-AE1F-E44E-B3F5-4699762027A1}" type="datetimeFigureOut">
              <a:rPr lang="en-US" smtClean="0"/>
              <a:pPr/>
              <a:t>10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7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D01AC-E7BD-C744-A9CE-F9619EDF022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60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944291" y="10737448"/>
            <a:ext cx="22035294" cy="740899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3888581" y="19586628"/>
            <a:ext cx="18146713" cy="883318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456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184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9128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641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369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0975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8257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3359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512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14096105" y="1848252"/>
            <a:ext cx="4374656" cy="39317276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972147" y="1848252"/>
            <a:ext cx="12691899" cy="3931727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1543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7843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047808" y="22210982"/>
            <a:ext cx="22035294" cy="6864921"/>
          </a:xfrm>
        </p:spPr>
        <p:txBody>
          <a:bodyPr anchor="t"/>
          <a:lstStyle>
            <a:lvl1pPr algn="l">
              <a:defRPr sz="151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047808" y="14649973"/>
            <a:ext cx="22035294" cy="7561011"/>
          </a:xfrm>
        </p:spPr>
        <p:txBody>
          <a:bodyPr anchor="b"/>
          <a:lstStyle>
            <a:lvl1pPr marL="0" indent="0">
              <a:buNone/>
              <a:defRPr sz="7600">
                <a:solidFill>
                  <a:schemeClr val="tx1">
                    <a:tint val="75000"/>
                  </a:schemeClr>
                </a:solidFill>
              </a:defRPr>
            </a:lvl1pPr>
            <a:lvl2pPr marL="1728216" indent="0">
              <a:buNone/>
              <a:defRPr sz="6800">
                <a:solidFill>
                  <a:schemeClr val="tx1">
                    <a:tint val="75000"/>
                  </a:schemeClr>
                </a:solidFill>
              </a:defRPr>
            </a:lvl2pPr>
            <a:lvl3pPr marL="3456432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3pPr>
            <a:lvl4pPr marL="5184648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4pPr>
            <a:lvl5pPr marL="6912864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5pPr>
            <a:lvl6pPr marL="8641080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6pPr>
            <a:lvl7pPr marL="10369296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7pPr>
            <a:lvl8pPr marL="12097512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8pPr>
            <a:lvl9pPr marL="13825728" indent="0">
              <a:buNone/>
              <a:defRPr sz="5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4200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972147" y="10753445"/>
            <a:ext cx="8533276" cy="30412085"/>
          </a:xfrm>
        </p:spPr>
        <p:txBody>
          <a:bodyPr/>
          <a:lstStyle>
            <a:lvl1pPr>
              <a:defRPr sz="10600"/>
            </a:lvl1pPr>
            <a:lvl2pPr>
              <a:defRPr sz="9100"/>
            </a:lvl2pPr>
            <a:lvl3pPr>
              <a:defRPr sz="7600"/>
            </a:lvl3pPr>
            <a:lvl4pPr>
              <a:defRPr sz="6800"/>
            </a:lvl4pPr>
            <a:lvl5pPr>
              <a:defRPr sz="6800"/>
            </a:lvl5pPr>
            <a:lvl6pPr>
              <a:defRPr sz="6800"/>
            </a:lvl6pPr>
            <a:lvl7pPr>
              <a:defRPr sz="6800"/>
            </a:lvl7pPr>
            <a:lvl8pPr>
              <a:defRPr sz="6800"/>
            </a:lvl8pPr>
            <a:lvl9pPr>
              <a:defRPr sz="6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9937487" y="10753445"/>
            <a:ext cx="8533276" cy="30412085"/>
          </a:xfrm>
        </p:spPr>
        <p:txBody>
          <a:bodyPr/>
          <a:lstStyle>
            <a:lvl1pPr>
              <a:defRPr sz="10600"/>
            </a:lvl1pPr>
            <a:lvl2pPr>
              <a:defRPr sz="9100"/>
            </a:lvl2pPr>
            <a:lvl3pPr>
              <a:defRPr sz="7600"/>
            </a:lvl3pPr>
            <a:lvl4pPr>
              <a:defRPr sz="6800"/>
            </a:lvl4pPr>
            <a:lvl5pPr>
              <a:defRPr sz="6800"/>
            </a:lvl5pPr>
            <a:lvl6pPr>
              <a:defRPr sz="6800"/>
            </a:lvl6pPr>
            <a:lvl7pPr>
              <a:defRPr sz="6800"/>
            </a:lvl7pPr>
            <a:lvl8pPr>
              <a:defRPr sz="6800"/>
            </a:lvl8pPr>
            <a:lvl9pPr>
              <a:defRPr sz="6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1744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296194" y="1384188"/>
            <a:ext cx="23331488" cy="5760773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296195" y="7737040"/>
            <a:ext cx="11454214" cy="3224430"/>
          </a:xfrm>
        </p:spPr>
        <p:txBody>
          <a:bodyPr anchor="b"/>
          <a:lstStyle>
            <a:lvl1pPr marL="0" indent="0">
              <a:buNone/>
              <a:defRPr sz="9100" b="1"/>
            </a:lvl1pPr>
            <a:lvl2pPr marL="1728216" indent="0">
              <a:buNone/>
              <a:defRPr sz="7600" b="1"/>
            </a:lvl2pPr>
            <a:lvl3pPr marL="3456432" indent="0">
              <a:buNone/>
              <a:defRPr sz="6800" b="1"/>
            </a:lvl3pPr>
            <a:lvl4pPr marL="5184648" indent="0">
              <a:buNone/>
              <a:defRPr sz="6000" b="1"/>
            </a:lvl4pPr>
            <a:lvl5pPr marL="6912864" indent="0">
              <a:buNone/>
              <a:defRPr sz="6000" b="1"/>
            </a:lvl5pPr>
            <a:lvl6pPr marL="8641080" indent="0">
              <a:buNone/>
              <a:defRPr sz="6000" b="1"/>
            </a:lvl6pPr>
            <a:lvl7pPr marL="10369296" indent="0">
              <a:buNone/>
              <a:defRPr sz="6000" b="1"/>
            </a:lvl7pPr>
            <a:lvl8pPr marL="12097512" indent="0">
              <a:buNone/>
              <a:defRPr sz="6000" b="1"/>
            </a:lvl8pPr>
            <a:lvl9pPr marL="13825728" indent="0">
              <a:buNone/>
              <a:defRPr sz="60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296195" y="10961469"/>
            <a:ext cx="11454214" cy="19914675"/>
          </a:xfrm>
        </p:spPr>
        <p:txBody>
          <a:bodyPr/>
          <a:lstStyle>
            <a:lvl1pPr>
              <a:defRPr sz="9100"/>
            </a:lvl1pPr>
            <a:lvl2pPr>
              <a:defRPr sz="7600"/>
            </a:lvl2pPr>
            <a:lvl3pPr>
              <a:defRPr sz="68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13168971" y="7737040"/>
            <a:ext cx="11458712" cy="3224430"/>
          </a:xfrm>
        </p:spPr>
        <p:txBody>
          <a:bodyPr anchor="b"/>
          <a:lstStyle>
            <a:lvl1pPr marL="0" indent="0">
              <a:buNone/>
              <a:defRPr sz="9100" b="1"/>
            </a:lvl1pPr>
            <a:lvl2pPr marL="1728216" indent="0">
              <a:buNone/>
              <a:defRPr sz="7600" b="1"/>
            </a:lvl2pPr>
            <a:lvl3pPr marL="3456432" indent="0">
              <a:buNone/>
              <a:defRPr sz="6800" b="1"/>
            </a:lvl3pPr>
            <a:lvl4pPr marL="5184648" indent="0">
              <a:buNone/>
              <a:defRPr sz="6000" b="1"/>
            </a:lvl4pPr>
            <a:lvl5pPr marL="6912864" indent="0">
              <a:buNone/>
              <a:defRPr sz="6000" b="1"/>
            </a:lvl5pPr>
            <a:lvl6pPr marL="8641080" indent="0">
              <a:buNone/>
              <a:defRPr sz="6000" b="1"/>
            </a:lvl6pPr>
            <a:lvl7pPr marL="10369296" indent="0">
              <a:buNone/>
              <a:defRPr sz="6000" b="1"/>
            </a:lvl7pPr>
            <a:lvl8pPr marL="12097512" indent="0">
              <a:buNone/>
              <a:defRPr sz="6000" b="1"/>
            </a:lvl8pPr>
            <a:lvl9pPr marL="13825728" indent="0">
              <a:buNone/>
              <a:defRPr sz="60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13168971" y="10961469"/>
            <a:ext cx="11458712" cy="19914675"/>
          </a:xfrm>
        </p:spPr>
        <p:txBody>
          <a:bodyPr/>
          <a:lstStyle>
            <a:lvl1pPr>
              <a:defRPr sz="9100"/>
            </a:lvl1pPr>
            <a:lvl2pPr>
              <a:defRPr sz="7600"/>
            </a:lvl2pPr>
            <a:lvl3pPr>
              <a:defRPr sz="68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855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472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7653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296196" y="1376186"/>
            <a:ext cx="8528777" cy="5856786"/>
          </a:xfrm>
        </p:spPr>
        <p:txBody>
          <a:bodyPr anchor="b"/>
          <a:lstStyle>
            <a:lvl1pPr algn="l">
              <a:defRPr sz="76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0135515" y="1376188"/>
            <a:ext cx="14492168" cy="29499962"/>
          </a:xfrm>
        </p:spPr>
        <p:txBody>
          <a:bodyPr/>
          <a:lstStyle>
            <a:lvl1pPr>
              <a:defRPr sz="12100"/>
            </a:lvl1pPr>
            <a:lvl2pPr>
              <a:defRPr sz="10600"/>
            </a:lvl2pPr>
            <a:lvl3pPr>
              <a:defRPr sz="91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296196" y="7232974"/>
            <a:ext cx="8528777" cy="23643176"/>
          </a:xfrm>
        </p:spPr>
        <p:txBody>
          <a:bodyPr/>
          <a:lstStyle>
            <a:lvl1pPr marL="0" indent="0">
              <a:buNone/>
              <a:defRPr sz="5300"/>
            </a:lvl1pPr>
            <a:lvl2pPr marL="1728216" indent="0">
              <a:buNone/>
              <a:defRPr sz="4500"/>
            </a:lvl2pPr>
            <a:lvl3pPr marL="3456432" indent="0">
              <a:buNone/>
              <a:defRPr sz="3800"/>
            </a:lvl3pPr>
            <a:lvl4pPr marL="5184648" indent="0">
              <a:buNone/>
              <a:defRPr sz="3400"/>
            </a:lvl4pPr>
            <a:lvl5pPr marL="6912864" indent="0">
              <a:buNone/>
              <a:defRPr sz="3400"/>
            </a:lvl5pPr>
            <a:lvl6pPr marL="8641080" indent="0">
              <a:buNone/>
              <a:defRPr sz="3400"/>
            </a:lvl6pPr>
            <a:lvl7pPr marL="10369296" indent="0">
              <a:buNone/>
              <a:defRPr sz="3400"/>
            </a:lvl7pPr>
            <a:lvl8pPr marL="12097512" indent="0">
              <a:buNone/>
              <a:defRPr sz="3400"/>
            </a:lvl8pPr>
            <a:lvl9pPr marL="13825728" indent="0">
              <a:buNone/>
              <a:defRPr sz="34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5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081261" y="24195249"/>
            <a:ext cx="15554325" cy="2856387"/>
          </a:xfrm>
        </p:spPr>
        <p:txBody>
          <a:bodyPr anchor="b"/>
          <a:lstStyle>
            <a:lvl1pPr algn="l">
              <a:defRPr sz="76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081261" y="3088413"/>
            <a:ext cx="15554325" cy="20738783"/>
          </a:xfrm>
        </p:spPr>
        <p:txBody>
          <a:bodyPr/>
          <a:lstStyle>
            <a:lvl1pPr marL="0" indent="0">
              <a:buNone/>
              <a:defRPr sz="12100"/>
            </a:lvl1pPr>
            <a:lvl2pPr marL="1728216" indent="0">
              <a:buNone/>
              <a:defRPr sz="10600"/>
            </a:lvl2pPr>
            <a:lvl3pPr marL="3456432" indent="0">
              <a:buNone/>
              <a:defRPr sz="9100"/>
            </a:lvl3pPr>
            <a:lvl4pPr marL="5184648" indent="0">
              <a:buNone/>
              <a:defRPr sz="7600"/>
            </a:lvl4pPr>
            <a:lvl5pPr marL="6912864" indent="0">
              <a:buNone/>
              <a:defRPr sz="7600"/>
            </a:lvl5pPr>
            <a:lvl6pPr marL="8641080" indent="0">
              <a:buNone/>
              <a:defRPr sz="7600"/>
            </a:lvl6pPr>
            <a:lvl7pPr marL="10369296" indent="0">
              <a:buNone/>
              <a:defRPr sz="7600"/>
            </a:lvl7pPr>
            <a:lvl8pPr marL="12097512" indent="0">
              <a:buNone/>
              <a:defRPr sz="7600"/>
            </a:lvl8pPr>
            <a:lvl9pPr marL="13825728" indent="0">
              <a:buNone/>
              <a:defRPr sz="76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5081261" y="27051635"/>
            <a:ext cx="15554325" cy="4056541"/>
          </a:xfrm>
        </p:spPr>
        <p:txBody>
          <a:bodyPr/>
          <a:lstStyle>
            <a:lvl1pPr marL="0" indent="0">
              <a:buNone/>
              <a:defRPr sz="5300"/>
            </a:lvl1pPr>
            <a:lvl2pPr marL="1728216" indent="0">
              <a:buNone/>
              <a:defRPr sz="4500"/>
            </a:lvl2pPr>
            <a:lvl3pPr marL="3456432" indent="0">
              <a:buNone/>
              <a:defRPr sz="3800"/>
            </a:lvl3pPr>
            <a:lvl4pPr marL="5184648" indent="0">
              <a:buNone/>
              <a:defRPr sz="3400"/>
            </a:lvl4pPr>
            <a:lvl5pPr marL="6912864" indent="0">
              <a:buNone/>
              <a:defRPr sz="3400"/>
            </a:lvl5pPr>
            <a:lvl6pPr marL="8641080" indent="0">
              <a:buNone/>
              <a:defRPr sz="3400"/>
            </a:lvl6pPr>
            <a:lvl7pPr marL="10369296" indent="0">
              <a:buNone/>
              <a:defRPr sz="3400"/>
            </a:lvl7pPr>
            <a:lvl8pPr marL="12097512" indent="0">
              <a:buNone/>
              <a:defRPr sz="3400"/>
            </a:lvl8pPr>
            <a:lvl9pPr marL="13825728" indent="0">
              <a:buNone/>
              <a:defRPr sz="34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1057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1296194" y="1384188"/>
            <a:ext cx="23331488" cy="5760773"/>
          </a:xfrm>
          <a:prstGeom prst="rect">
            <a:avLst/>
          </a:prstGeom>
        </p:spPr>
        <p:txBody>
          <a:bodyPr vert="horz" lIns="345643" tIns="172822" rIns="345643" bIns="172822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296194" y="8065088"/>
            <a:ext cx="23331488" cy="22811062"/>
          </a:xfrm>
          <a:prstGeom prst="rect">
            <a:avLst/>
          </a:prstGeom>
        </p:spPr>
        <p:txBody>
          <a:bodyPr vert="horz" lIns="345643" tIns="172822" rIns="345643" bIns="172822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1296194" y="32036303"/>
            <a:ext cx="6048904" cy="1840246"/>
          </a:xfrm>
          <a:prstGeom prst="rect">
            <a:avLst/>
          </a:prstGeom>
        </p:spPr>
        <p:txBody>
          <a:bodyPr vert="horz" lIns="345643" tIns="172822" rIns="345643" bIns="172822" rtlCol="0" anchor="ctr"/>
          <a:lstStyle>
            <a:lvl1pPr algn="l">
              <a:defRPr sz="4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7A55E-AB06-EC48-A998-D0AC7544F02A}" type="datetimeFigureOut">
              <a:rPr lang="de-DE" smtClean="0"/>
              <a:pPr/>
              <a:t>15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8857324" y="32036303"/>
            <a:ext cx="8209227" cy="1840246"/>
          </a:xfrm>
          <a:prstGeom prst="rect">
            <a:avLst/>
          </a:prstGeom>
        </p:spPr>
        <p:txBody>
          <a:bodyPr vert="horz" lIns="345643" tIns="172822" rIns="345643" bIns="172822" rtlCol="0" anchor="ctr"/>
          <a:lstStyle>
            <a:lvl1pPr algn="ctr">
              <a:defRPr sz="4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18578777" y="32036303"/>
            <a:ext cx="6048904" cy="1840246"/>
          </a:xfrm>
          <a:prstGeom prst="rect">
            <a:avLst/>
          </a:prstGeom>
        </p:spPr>
        <p:txBody>
          <a:bodyPr vert="horz" lIns="345643" tIns="172822" rIns="345643" bIns="172822" rtlCol="0" anchor="ctr"/>
          <a:lstStyle>
            <a:lvl1pPr algn="r">
              <a:defRPr sz="4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CD718-25AA-3A4B-BC2F-2B4693C9E5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7627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728216" rtl="0" eaLnBrk="1" latinLnBrk="0" hangingPunct="1">
        <a:spcBef>
          <a:spcPct val="0"/>
        </a:spcBef>
        <a:buNone/>
        <a:defRPr sz="1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96162" indent="-1296162" algn="l" defTabSz="1728216" rtl="0" eaLnBrk="1" latinLnBrk="0" hangingPunct="1">
        <a:spcBef>
          <a:spcPct val="20000"/>
        </a:spcBef>
        <a:buFont typeface="Arial"/>
        <a:buChar char="•"/>
        <a:defRPr sz="12100" kern="1200">
          <a:solidFill>
            <a:schemeClr val="tx1"/>
          </a:solidFill>
          <a:latin typeface="+mn-lt"/>
          <a:ea typeface="+mn-ea"/>
          <a:cs typeface="+mn-cs"/>
        </a:defRPr>
      </a:lvl1pPr>
      <a:lvl2pPr marL="2808351" indent="-1080135" algn="l" defTabSz="1728216" rtl="0" eaLnBrk="1" latinLnBrk="0" hangingPunct="1">
        <a:spcBef>
          <a:spcPct val="20000"/>
        </a:spcBef>
        <a:buFont typeface="Arial"/>
        <a:buChar char="–"/>
        <a:defRPr sz="10600" kern="1200">
          <a:solidFill>
            <a:schemeClr val="tx1"/>
          </a:solidFill>
          <a:latin typeface="+mn-lt"/>
          <a:ea typeface="+mn-ea"/>
          <a:cs typeface="+mn-cs"/>
        </a:defRPr>
      </a:lvl2pPr>
      <a:lvl3pPr marL="4320540" indent="-864108" algn="l" defTabSz="1728216" rtl="0" eaLnBrk="1" latinLnBrk="0" hangingPunct="1">
        <a:spcBef>
          <a:spcPct val="20000"/>
        </a:spcBef>
        <a:buFont typeface="Arial"/>
        <a:buChar char="•"/>
        <a:defRPr sz="9100" kern="1200">
          <a:solidFill>
            <a:schemeClr val="tx1"/>
          </a:solidFill>
          <a:latin typeface="+mn-lt"/>
          <a:ea typeface="+mn-ea"/>
          <a:cs typeface="+mn-cs"/>
        </a:defRPr>
      </a:lvl3pPr>
      <a:lvl4pPr marL="6048756" indent="-864108" algn="l" defTabSz="1728216" rtl="0" eaLnBrk="1" latinLnBrk="0" hangingPunct="1">
        <a:spcBef>
          <a:spcPct val="20000"/>
        </a:spcBef>
        <a:buFont typeface="Arial"/>
        <a:buChar char="–"/>
        <a:defRPr sz="7600" kern="1200">
          <a:solidFill>
            <a:schemeClr val="tx1"/>
          </a:solidFill>
          <a:latin typeface="+mn-lt"/>
          <a:ea typeface="+mn-ea"/>
          <a:cs typeface="+mn-cs"/>
        </a:defRPr>
      </a:lvl4pPr>
      <a:lvl5pPr marL="7776972" indent="-864108" algn="l" defTabSz="1728216" rtl="0" eaLnBrk="1" latinLnBrk="0" hangingPunct="1">
        <a:spcBef>
          <a:spcPct val="20000"/>
        </a:spcBef>
        <a:buFont typeface="Arial"/>
        <a:buChar char="»"/>
        <a:defRPr sz="7600" kern="1200">
          <a:solidFill>
            <a:schemeClr val="tx1"/>
          </a:solidFill>
          <a:latin typeface="+mn-lt"/>
          <a:ea typeface="+mn-ea"/>
          <a:cs typeface="+mn-cs"/>
        </a:defRPr>
      </a:lvl5pPr>
      <a:lvl6pPr marL="9505188" indent="-864108" algn="l" defTabSz="1728216" rtl="0" eaLnBrk="1" latinLnBrk="0" hangingPunct="1">
        <a:spcBef>
          <a:spcPct val="20000"/>
        </a:spcBef>
        <a:buFont typeface="Arial"/>
        <a:buChar char="•"/>
        <a:defRPr sz="7600" kern="1200">
          <a:solidFill>
            <a:schemeClr val="tx1"/>
          </a:solidFill>
          <a:latin typeface="+mn-lt"/>
          <a:ea typeface="+mn-ea"/>
          <a:cs typeface="+mn-cs"/>
        </a:defRPr>
      </a:lvl6pPr>
      <a:lvl7pPr marL="11233404" indent="-864108" algn="l" defTabSz="1728216" rtl="0" eaLnBrk="1" latinLnBrk="0" hangingPunct="1">
        <a:spcBef>
          <a:spcPct val="20000"/>
        </a:spcBef>
        <a:buFont typeface="Arial"/>
        <a:buChar char="•"/>
        <a:defRPr sz="7600" kern="1200">
          <a:solidFill>
            <a:schemeClr val="tx1"/>
          </a:solidFill>
          <a:latin typeface="+mn-lt"/>
          <a:ea typeface="+mn-ea"/>
          <a:cs typeface="+mn-cs"/>
        </a:defRPr>
      </a:lvl7pPr>
      <a:lvl8pPr marL="12961620" indent="-864108" algn="l" defTabSz="1728216" rtl="0" eaLnBrk="1" latinLnBrk="0" hangingPunct="1">
        <a:spcBef>
          <a:spcPct val="20000"/>
        </a:spcBef>
        <a:buFont typeface="Arial"/>
        <a:buChar char="•"/>
        <a:defRPr sz="7600" kern="1200">
          <a:solidFill>
            <a:schemeClr val="tx1"/>
          </a:solidFill>
          <a:latin typeface="+mn-lt"/>
          <a:ea typeface="+mn-ea"/>
          <a:cs typeface="+mn-cs"/>
        </a:defRPr>
      </a:lvl8pPr>
      <a:lvl9pPr marL="14689836" indent="-864108" algn="l" defTabSz="1728216" rtl="0" eaLnBrk="1" latinLnBrk="0" hangingPunct="1">
        <a:spcBef>
          <a:spcPct val="20000"/>
        </a:spcBef>
        <a:buFont typeface="Arial"/>
        <a:buChar char="•"/>
        <a:defRPr sz="7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1pPr>
      <a:lvl2pPr marL="1728216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2pPr>
      <a:lvl3pPr marL="3456432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3pPr>
      <a:lvl4pPr marL="5184648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4pPr>
      <a:lvl5pPr marL="6912864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5pPr>
      <a:lvl6pPr marL="8641080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6pPr>
      <a:lvl7pPr marL="10369296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7pPr>
      <a:lvl8pPr marL="12097512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8pPr>
      <a:lvl9pPr marL="13825728" algn="l" defTabSz="1728216" rtl="0" eaLnBrk="1" latinLnBrk="0" hangingPunct="1">
        <a:defRPr sz="6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13" Type="http://schemas.openxmlformats.org/officeDocument/2006/relationships/image" Target="../media/image9.png"/><Relationship Id="rId3" Type="http://schemas.openxmlformats.org/officeDocument/2006/relationships/image" Target="../media/image5.png"/><Relationship Id="rId7" Type="http://schemas.openxmlformats.org/officeDocument/2006/relationships/oleObject" Target="../embeddings/oleObject1.bin"/><Relationship Id="rId12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11" Type="http://schemas.openxmlformats.org/officeDocument/2006/relationships/oleObject" Target="../embeddings/oleObject3.bin"/><Relationship Id="rId5" Type="http://schemas.openxmlformats.org/officeDocument/2006/relationships/image" Target="../media/image7.png"/><Relationship Id="rId15" Type="http://schemas.openxmlformats.org/officeDocument/2006/relationships/image" Target="../media/image4.emf"/><Relationship Id="rId10" Type="http://schemas.openxmlformats.org/officeDocument/2006/relationships/image" Target="../media/image2.emf"/><Relationship Id="rId4" Type="http://schemas.openxmlformats.org/officeDocument/2006/relationships/image" Target="../media/image6.png"/><Relationship Id="rId9" Type="http://schemas.openxmlformats.org/officeDocument/2006/relationships/oleObject" Target="../embeddings/oleObject2.bin"/><Relationship Id="rId14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oleObject" Target="../embeddings/oleObject7.bin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1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3.png"/><Relationship Id="rId11" Type="http://schemas.openxmlformats.org/officeDocument/2006/relationships/oleObject" Target="../embeddings/oleObject6.bin"/><Relationship Id="rId5" Type="http://schemas.openxmlformats.org/officeDocument/2006/relationships/image" Target="../media/image22.png"/><Relationship Id="rId10" Type="http://schemas.openxmlformats.org/officeDocument/2006/relationships/image" Target="../media/image17.emf"/><Relationship Id="rId4" Type="http://schemas.openxmlformats.org/officeDocument/2006/relationships/image" Target="../media/image21.png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722B0AA-52D0-466C-9E13-ACF1E2C050AC}"/>
              </a:ext>
            </a:extLst>
          </p:cNvPr>
          <p:cNvSpPr txBox="1"/>
          <p:nvPr/>
        </p:nvSpPr>
        <p:spPr>
          <a:xfrm flipH="1">
            <a:off x="264609" y="384039"/>
            <a:ext cx="1202105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</a:t>
            </a:r>
            <a:endParaRPr lang="en-DE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801B698-9C2B-4177-B06A-7F8CF12DC10D}"/>
              </a:ext>
            </a:extLst>
          </p:cNvPr>
          <p:cNvSpPr txBox="1"/>
          <p:nvPr/>
        </p:nvSpPr>
        <p:spPr>
          <a:xfrm>
            <a:off x="501649" y="1659306"/>
            <a:ext cx="615874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  <a:endParaRPr lang="en-DE" b="1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45DDD61E-953B-4438-8CF0-BBDEA01859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3895" y="1725969"/>
            <a:ext cx="7474286" cy="720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2236C6C-63DB-49D7-B8DF-EDBA18FAEF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2572" y="9919441"/>
            <a:ext cx="7314286" cy="7200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217DA8A-FE2B-430B-AAB0-F4B7921996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49037" y="1786658"/>
            <a:ext cx="7474286" cy="7200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A41ACB9-572F-40C5-8005-BC64E332A9C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999382" y="10235935"/>
            <a:ext cx="7314286" cy="7200000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AAFB1BD5-143E-4FE7-BFD9-8C035C57AC41}"/>
              </a:ext>
            </a:extLst>
          </p:cNvPr>
          <p:cNvCxnSpPr>
            <a:cxnSpLocks/>
          </p:cNvCxnSpPr>
          <p:nvPr/>
        </p:nvCxnSpPr>
        <p:spPr>
          <a:xfrm flipH="1">
            <a:off x="12882808" y="8239903"/>
            <a:ext cx="5760454" cy="228185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E66DB9E-686F-400B-A976-ED0876BD5E12}"/>
              </a:ext>
            </a:extLst>
          </p:cNvPr>
          <p:cNvCxnSpPr>
            <a:cxnSpLocks/>
          </p:cNvCxnSpPr>
          <p:nvPr/>
        </p:nvCxnSpPr>
        <p:spPr>
          <a:xfrm flipV="1">
            <a:off x="10482082" y="13473711"/>
            <a:ext cx="3224936" cy="93161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F5512996-D47D-475A-94EC-2459A53E95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9199248"/>
              </p:ext>
            </p:extLst>
          </p:nvPr>
        </p:nvGraphicFramePr>
        <p:xfrm>
          <a:off x="14284137" y="26811997"/>
          <a:ext cx="11753850" cy="7469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8" r:id="rId7" imgW="5128693" imgH="3259754" progId="Prism8.Document">
                  <p:embed/>
                </p:oleObj>
              </mc:Choice>
              <mc:Fallback>
                <p:oleObj name="Prism 8" r:id="rId7" imgW="5128693" imgH="3259754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F351AEF-6B7B-40B8-894B-7C27B3349B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284137" y="26811997"/>
                        <a:ext cx="11753850" cy="7469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58D57913-3465-4068-BD01-0D7850CD8C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8196012"/>
              </p:ext>
            </p:extLst>
          </p:nvPr>
        </p:nvGraphicFramePr>
        <p:xfrm>
          <a:off x="11955463" y="18796000"/>
          <a:ext cx="13858875" cy="6726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1" name="Prism 8" r:id="rId9" imgW="8182283" imgH="3973219" progId="Prism8.Document">
                  <p:embed/>
                </p:oleObj>
              </mc:Choice>
              <mc:Fallback>
                <p:oleObj name="Prism 8" r:id="rId9" imgW="8182283" imgH="3973219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B968E97-8B93-4408-84CE-704993F817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955463" y="18796000"/>
                        <a:ext cx="13858875" cy="6726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A5083A02-705C-4C84-A0C4-99F2282723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5566513"/>
              </p:ext>
            </p:extLst>
          </p:nvPr>
        </p:nvGraphicFramePr>
        <p:xfrm>
          <a:off x="695325" y="26934859"/>
          <a:ext cx="13796963" cy="6340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2" name="Prism 8" r:id="rId11" imgW="8145910" imgH="3744522" progId="Prism8.Document">
                  <p:embed/>
                </p:oleObj>
              </mc:Choice>
              <mc:Fallback>
                <p:oleObj name="Prism 8" r:id="rId11" imgW="8145910" imgH="3744522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58D57913-3465-4068-BD01-0D7850CD8C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95325" y="26934859"/>
                        <a:ext cx="13796963" cy="6340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4BAB3BC0-CC26-4761-874C-39F894CFEF8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743217" y="1725969"/>
            <a:ext cx="7474286" cy="7200000"/>
          </a:xfrm>
          <a:prstGeom prst="rect">
            <a:avLst/>
          </a:prstGeom>
        </p:spPr>
      </p:pic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A11BB127-04C8-4172-9D53-D87F6C4135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815122"/>
              </p:ext>
            </p:extLst>
          </p:nvPr>
        </p:nvGraphicFramePr>
        <p:xfrm>
          <a:off x="430213" y="18691225"/>
          <a:ext cx="11855450" cy="681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3" name="Prism 8" r:id="rId14" imgW="5174430" imgH="2974512" progId="Prism8.Document">
                  <p:embed/>
                </p:oleObj>
              </mc:Choice>
              <mc:Fallback>
                <p:oleObj name="Prism 8" r:id="rId14" imgW="5174430" imgH="2974512" progId="Prism8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F5512996-D47D-475A-94EC-2459A53E95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30213" y="18691225"/>
                        <a:ext cx="11855450" cy="681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F7B6F9D-1472-46D9-870D-68D3B5DF63D9}"/>
              </a:ext>
            </a:extLst>
          </p:cNvPr>
          <p:cNvSpPr txBox="1"/>
          <p:nvPr/>
        </p:nvSpPr>
        <p:spPr>
          <a:xfrm>
            <a:off x="501649" y="18796000"/>
            <a:ext cx="652743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  <a:endParaRPr lang="en-DE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A74580-87A7-46FB-9FEE-AEF78136EB16}"/>
              </a:ext>
            </a:extLst>
          </p:cNvPr>
          <p:cNvSpPr txBox="1"/>
          <p:nvPr/>
        </p:nvSpPr>
        <p:spPr>
          <a:xfrm>
            <a:off x="11394621" y="18658731"/>
            <a:ext cx="553357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  <a:endParaRPr lang="en-DE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F71F0B-D1AA-49A4-A80E-39FC89C8388E}"/>
              </a:ext>
            </a:extLst>
          </p:cNvPr>
          <p:cNvSpPr txBox="1"/>
          <p:nvPr/>
        </p:nvSpPr>
        <p:spPr>
          <a:xfrm>
            <a:off x="183322" y="26773993"/>
            <a:ext cx="652743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  <a:endParaRPr lang="en-DE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88D00A-3C09-489C-B6E3-12FD298A026D}"/>
              </a:ext>
            </a:extLst>
          </p:cNvPr>
          <p:cNvSpPr txBox="1"/>
          <p:nvPr/>
        </p:nvSpPr>
        <p:spPr>
          <a:xfrm>
            <a:off x="14981431" y="26475804"/>
            <a:ext cx="4571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e</a:t>
            </a:r>
            <a:endParaRPr lang="en-DE" b="1" dirty="0"/>
          </a:p>
        </p:txBody>
      </p:sp>
    </p:spTree>
    <p:extLst>
      <p:ext uri="{BB962C8B-B14F-4D97-AF65-F5344CB8AC3E}">
        <p14:creationId xmlns:p14="http://schemas.microsoft.com/office/powerpoint/2010/main" val="1239688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91BD5CE-27A3-4C72-8B7F-604803BF15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3809" y="3972430"/>
            <a:ext cx="7474285" cy="720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62ADE3-79F1-482E-BD26-5742AE9584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42258" y="3941953"/>
            <a:ext cx="7474287" cy="720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937940B-F729-4971-AEE9-33BFDA8885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04873" y="3972430"/>
            <a:ext cx="7474287" cy="720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5F6FA45-E9A6-4D80-B967-F1AE5F654B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77674" y="11850916"/>
            <a:ext cx="7474284" cy="72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BD1846D-243C-4DD3-A4C5-3112E868F8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61403" y="11850916"/>
            <a:ext cx="7314285" cy="720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A0937F5-4B5F-4782-A7F5-A2434050246A}"/>
              </a:ext>
            </a:extLst>
          </p:cNvPr>
          <p:cNvSpPr txBox="1"/>
          <p:nvPr/>
        </p:nvSpPr>
        <p:spPr>
          <a:xfrm>
            <a:off x="667754" y="3293944"/>
            <a:ext cx="615874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  <a:endParaRPr lang="en-DE" b="1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1428787-610C-4589-A268-45E3466123DE}"/>
              </a:ext>
            </a:extLst>
          </p:cNvPr>
          <p:cNvCxnSpPr/>
          <p:nvPr/>
        </p:nvCxnSpPr>
        <p:spPr>
          <a:xfrm flipH="1">
            <a:off x="12717773" y="9406675"/>
            <a:ext cx="5532175" cy="275054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0CF7B22C-88AE-4D05-8573-49BB4FBD5ADC}"/>
              </a:ext>
            </a:extLst>
          </p:cNvPr>
          <p:cNvCxnSpPr/>
          <p:nvPr/>
        </p:nvCxnSpPr>
        <p:spPr>
          <a:xfrm>
            <a:off x="12651958" y="14330792"/>
            <a:ext cx="220652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F5A8227-16A5-48A5-B4B9-6F07CDB3BB39}"/>
              </a:ext>
            </a:extLst>
          </p:cNvPr>
          <p:cNvSpPr txBox="1"/>
          <p:nvPr/>
        </p:nvSpPr>
        <p:spPr>
          <a:xfrm>
            <a:off x="904760" y="19160015"/>
            <a:ext cx="70931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endParaRPr lang="en-DE" b="1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5F63786-6D14-45BB-915E-024BDF0F4A41}"/>
              </a:ext>
            </a:extLst>
          </p:cNvPr>
          <p:cNvSpPr/>
          <p:nvPr/>
        </p:nvSpPr>
        <p:spPr>
          <a:xfrm>
            <a:off x="9157143" y="31766559"/>
            <a:ext cx="988414" cy="10058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6029383-F9FD-4AD4-B557-2ED49826B674}"/>
              </a:ext>
            </a:extLst>
          </p:cNvPr>
          <p:cNvSpPr txBox="1"/>
          <p:nvPr/>
        </p:nvSpPr>
        <p:spPr>
          <a:xfrm flipH="1">
            <a:off x="264609" y="384039"/>
            <a:ext cx="1202105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2</a:t>
            </a:r>
            <a:endParaRPr lang="en-DE" b="1" dirty="0"/>
          </a:p>
        </p:txBody>
      </p:sp>
      <p:pic>
        <p:nvPicPr>
          <p:cNvPr id="20" name="Picture 19" descr="Graphical user interface&#10;&#10;Description automatically generated">
            <a:extLst>
              <a:ext uri="{FF2B5EF4-FFF2-40B4-BE49-F238E27FC236}">
                <a16:creationId xmlns:a16="http://schemas.microsoft.com/office/drawing/2014/main" id="{DEA03363-83EF-475C-8554-B45C92D5D43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4162"/>
          <a:stretch/>
        </p:blipFill>
        <p:spPr>
          <a:xfrm>
            <a:off x="6720023" y="27362278"/>
            <a:ext cx="15955665" cy="7200000"/>
          </a:xfrm>
          <a:prstGeom prst="rect">
            <a:avLst/>
          </a:prstGeom>
        </p:spPr>
      </p:pic>
      <p:pic>
        <p:nvPicPr>
          <p:cNvPr id="21" name="Picture 20" descr="Chart&#10;&#10;Description automatically generated">
            <a:extLst>
              <a:ext uri="{FF2B5EF4-FFF2-40B4-BE49-F238E27FC236}">
                <a16:creationId xmlns:a16="http://schemas.microsoft.com/office/drawing/2014/main" id="{3EF35B90-573E-4929-9C3C-75D3C051350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24003"/>
          <a:stretch/>
        </p:blipFill>
        <p:spPr>
          <a:xfrm>
            <a:off x="1778610" y="19606597"/>
            <a:ext cx="22891995" cy="7200000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9B622F6-C9C2-45D9-A09F-192C4B516631}"/>
              </a:ext>
            </a:extLst>
          </p:cNvPr>
          <p:cNvCxnSpPr/>
          <p:nvPr/>
        </p:nvCxnSpPr>
        <p:spPr>
          <a:xfrm flipH="1">
            <a:off x="13755218" y="25709166"/>
            <a:ext cx="4494730" cy="233574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F12735DF-4D95-4E57-B54D-B656B25FE27F}"/>
              </a:ext>
            </a:extLst>
          </p:cNvPr>
          <p:cNvCxnSpPr/>
          <p:nvPr/>
        </p:nvCxnSpPr>
        <p:spPr>
          <a:xfrm>
            <a:off x="10145557" y="30157199"/>
            <a:ext cx="5857026" cy="80507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532831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5FF7972-18FD-4F63-97CF-96ED22B397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27680" y="2903233"/>
            <a:ext cx="7474287" cy="7200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9F12F0E-27D3-4137-9A3A-23121311C1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3492" y="11247219"/>
            <a:ext cx="7474287" cy="7200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372B090-0EBA-4BC7-A8DE-F80C617AF7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70188" y="2958869"/>
            <a:ext cx="7474287" cy="720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11B9379-0328-4280-B53B-C45691F2BD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51511" y="11247219"/>
            <a:ext cx="7314285" cy="720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23FCDAC-C45B-4FE5-8429-1A4026AFE1B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0563"/>
          <a:stretch/>
        </p:blipFill>
        <p:spPr>
          <a:xfrm>
            <a:off x="1851676" y="2958869"/>
            <a:ext cx="7159101" cy="720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95C40B1-D019-4506-A3AE-9C8D6D6212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890602" y="11247219"/>
            <a:ext cx="7314285" cy="7200000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DB11AAF8-09C5-48C5-9C3B-00AA0212E765}"/>
              </a:ext>
            </a:extLst>
          </p:cNvPr>
          <p:cNvCxnSpPr>
            <a:cxnSpLocks/>
          </p:cNvCxnSpPr>
          <p:nvPr/>
        </p:nvCxnSpPr>
        <p:spPr>
          <a:xfrm flipV="1">
            <a:off x="15309068" y="14847219"/>
            <a:ext cx="2313455" cy="82574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1D65DE4-26FA-4E75-B47E-4C9E37AEE6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289036"/>
              </p:ext>
            </p:extLst>
          </p:nvPr>
        </p:nvGraphicFramePr>
        <p:xfrm>
          <a:off x="1366838" y="27176413"/>
          <a:ext cx="11161712" cy="725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8" r:id="rId9" imgW="4891003" imgH="3180520" progId="Prism8.Document">
                  <p:embed/>
                </p:oleObj>
              </mc:Choice>
              <mc:Fallback>
                <p:oleObj name="Prism 8" r:id="rId9" imgW="4891003" imgH="318052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81B82E0A-70A8-4512-88BC-61D70B6548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66838" y="27176413"/>
                        <a:ext cx="11161712" cy="725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BB464F5-D3B5-4308-A72A-A444754C95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3756896"/>
              </p:ext>
            </p:extLst>
          </p:nvPr>
        </p:nvGraphicFramePr>
        <p:xfrm>
          <a:off x="1495425" y="19000788"/>
          <a:ext cx="10701338" cy="786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4" name="Prism 8" r:id="rId11" imgW="6624336" imgH="4868202" progId="Prism8.Document">
                  <p:embed/>
                </p:oleObj>
              </mc:Choice>
              <mc:Fallback>
                <p:oleObj name="Prism 8" r:id="rId11" imgW="6624336" imgH="4868202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1F0A877-A95F-4624-A4A0-9CECDF61FF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495425" y="19000788"/>
                        <a:ext cx="10701338" cy="786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E82D8F0-887E-4D70-8844-7A1065F655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626005"/>
              </p:ext>
            </p:extLst>
          </p:nvPr>
        </p:nvGraphicFramePr>
        <p:xfrm>
          <a:off x="13490575" y="19738975"/>
          <a:ext cx="12077700" cy="768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5" name="Prism 8" r:id="rId13" imgW="8200650" imgH="5221873" progId="Prism8.Document">
                  <p:embed/>
                </p:oleObj>
              </mc:Choice>
              <mc:Fallback>
                <p:oleObj name="Prism 8" r:id="rId13" imgW="8200650" imgH="5221873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F9E06B8-3B30-4905-A626-485EE54EBA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3490575" y="19738975"/>
                        <a:ext cx="12077700" cy="768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22BA1A73-5994-44A9-A889-C3660B3BA68B}"/>
              </a:ext>
            </a:extLst>
          </p:cNvPr>
          <p:cNvSpPr txBox="1"/>
          <p:nvPr/>
        </p:nvSpPr>
        <p:spPr>
          <a:xfrm>
            <a:off x="1147773" y="3502174"/>
            <a:ext cx="4571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  <a:endParaRPr lang="en-DE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109CD0-3A96-44E3-84F6-8A2650F5F536}"/>
              </a:ext>
            </a:extLst>
          </p:cNvPr>
          <p:cNvSpPr txBox="1"/>
          <p:nvPr/>
        </p:nvSpPr>
        <p:spPr>
          <a:xfrm>
            <a:off x="837460" y="19365699"/>
            <a:ext cx="652743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  <a:endParaRPr lang="en-DE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C7DCB3-B01A-4C25-BF4B-85DD796B78AB}"/>
              </a:ext>
            </a:extLst>
          </p:cNvPr>
          <p:cNvSpPr txBox="1"/>
          <p:nvPr/>
        </p:nvSpPr>
        <p:spPr>
          <a:xfrm>
            <a:off x="12528174" y="19238013"/>
            <a:ext cx="88996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  <a:endParaRPr lang="en-DE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094808-4DEB-44F6-B10E-5F518973DB13}"/>
              </a:ext>
            </a:extLst>
          </p:cNvPr>
          <p:cNvSpPr txBox="1"/>
          <p:nvPr/>
        </p:nvSpPr>
        <p:spPr>
          <a:xfrm>
            <a:off x="867120" y="27356493"/>
            <a:ext cx="652743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  <a:endParaRPr lang="en-DE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4DF2E8F-F3B2-467B-A420-A039E202C6E8}"/>
              </a:ext>
            </a:extLst>
          </p:cNvPr>
          <p:cNvSpPr txBox="1"/>
          <p:nvPr/>
        </p:nvSpPr>
        <p:spPr>
          <a:xfrm flipH="1">
            <a:off x="264609" y="384039"/>
            <a:ext cx="1202105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3</a:t>
            </a:r>
            <a:endParaRPr lang="en-DE" b="1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ECA796F-8B88-4A42-8AED-4B75C60FBEDE}"/>
              </a:ext>
            </a:extLst>
          </p:cNvPr>
          <p:cNvCxnSpPr/>
          <p:nvPr/>
        </p:nvCxnSpPr>
        <p:spPr>
          <a:xfrm flipH="1">
            <a:off x="8667779" y="8933764"/>
            <a:ext cx="10329258" cy="231345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5017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20</Words>
  <Application>Microsoft Office PowerPoint</Application>
  <PresentationFormat>Custom</PresentationFormat>
  <Paragraphs>1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-Design</vt:lpstr>
      <vt:lpstr>Prism 8</vt:lpstr>
      <vt:lpstr>PowerPoint Presentation</vt:lpstr>
      <vt:lpstr>PowerPoint Presentation</vt:lpstr>
      <vt:lpstr>PowerPoint Presentation</vt:lpstr>
    </vt:vector>
  </TitlesOfParts>
  <Company>Institut of Immu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rl Lang</dc:creator>
  <cp:lastModifiedBy>MDPI-17</cp:lastModifiedBy>
  <cp:revision>3467</cp:revision>
  <cp:lastPrinted>2021-05-31T09:12:07Z</cp:lastPrinted>
  <dcterms:created xsi:type="dcterms:W3CDTF">2013-05-15T15:49:13Z</dcterms:created>
  <dcterms:modified xsi:type="dcterms:W3CDTF">2021-10-15T09:41:41Z</dcterms:modified>
</cp:coreProperties>
</file>